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5758FB7-9AC5-4552-8A53-C91805E547FA}" styleName="Style à thème 1 - Accentuation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52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957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77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75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847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265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2122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08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3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146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42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1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68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330505"/>
              </p:ext>
            </p:extLst>
          </p:nvPr>
        </p:nvGraphicFramePr>
        <p:xfrm>
          <a:off x="63346" y="451708"/>
          <a:ext cx="6729027" cy="6594410"/>
        </p:xfrm>
        <a:graphic>
          <a:graphicData uri="http://schemas.openxmlformats.org/drawingml/2006/table">
            <a:tbl>
              <a:tblPr/>
              <a:tblGrid>
                <a:gridCol w="1219320">
                  <a:extLst>
                    <a:ext uri="{9D8B030D-6E8A-4147-A177-3AD203B41FA5}">
                      <a16:colId xmlns:a16="http://schemas.microsoft.com/office/drawing/2014/main" val="1441449213"/>
                    </a:ext>
                  </a:extLst>
                </a:gridCol>
                <a:gridCol w="2473359">
                  <a:extLst>
                    <a:ext uri="{9D8B030D-6E8A-4147-A177-3AD203B41FA5}">
                      <a16:colId xmlns:a16="http://schemas.microsoft.com/office/drawing/2014/main" val="2537075546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1474787242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4054024104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1358658131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4215092396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955281656"/>
                    </a:ext>
                  </a:extLst>
                </a:gridCol>
                <a:gridCol w="506058">
                  <a:extLst>
                    <a:ext uri="{9D8B030D-6E8A-4147-A177-3AD203B41FA5}">
                      <a16:colId xmlns:a16="http://schemas.microsoft.com/office/drawing/2014/main" val="14221773"/>
                    </a:ext>
                  </a:extLst>
                </a:gridCol>
              </a:tblGrid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Biological-Process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924102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Biological-Process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ges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37558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09403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1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0E-0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330335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Biological-Process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olysis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147956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783359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0E-0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6505714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39129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4988702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ncreatic secretion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91666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85714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1513809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digestion and absorption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312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230769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0E-1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1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77412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urity onset diabetes of the young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89583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853146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0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0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7288930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roactive ligand-receptor interaction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4062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14792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0E-0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0289824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arian steroidogenesis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83333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92307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0E-0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504125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t digestion and absorption - Mus musculus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89583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139860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172880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tion of lipolysis in adipocytes - Mus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sculu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ouse)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95833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24175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0E-0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733004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432830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3349513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spac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497071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2650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0E-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295878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reg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8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306483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400260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0E-1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0E-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1355057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region par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07962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951059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0E-1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0E-1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5310089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sicle lume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9596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.84313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0E-0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4733989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plasmic vesicle lume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9596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.84313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0E-0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788238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retory granul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2551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1172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0E-0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0E-0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442692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retory vesicl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35867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421568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0E-0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96890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6881504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5604467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ine-type endopeptid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81591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461154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41307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ine-type peptid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076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0018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5727742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ine hydrol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78615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449517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E+00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1927141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ase activity, acting on L-amino acid peptides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66503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69681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0E-1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0595322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92523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98510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E-1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0E-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558597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dopeptid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12801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1495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0E-13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0E-1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303159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l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134384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669457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0E-0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0E-0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058050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rmon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45536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6526611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0E-0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9916226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glyceride lip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840138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4191177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0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5500044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ohydrate binding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08165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365196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0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9782297"/>
                  </a:ext>
                </a:extLst>
              </a:tr>
              <a:tr h="18858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llocarboxypeptidase activity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95155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94771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04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0E-02</a:t>
                      </a:r>
                    </a:p>
                  </a:txBody>
                  <a:tcPr marL="5616" marR="5616" marT="56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2286421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20949" y="7549158"/>
            <a:ext cx="6616102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100" b="1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S3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Table. 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Gene ontology from differential expression analysis of </a:t>
            </a:r>
            <a:r>
              <a:rPr lang="en-GB" sz="11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NAseq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data for Venus+ alpha cells in HFD 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mice.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Differentially expressed genes for Venus+ alpha cells between HFD and LFD mice (</a:t>
            </a:r>
            <a:r>
              <a:rPr lang="en-GB" sz="11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EdgeR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 method) were analysed for GO enrichment and KEGG pathway analysis using </a:t>
            </a:r>
            <a:r>
              <a:rPr lang="en-GB" sz="11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WebGestalt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 2017 software.</a:t>
            </a:r>
            <a:endParaRPr lang="fr-FR" sz="11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57157223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99</TotalTime>
  <Words>391</Words>
  <Application>Microsoft Office PowerPoint</Application>
  <PresentationFormat>Affichage à l'écran (4:3)</PresentationFormat>
  <Paragraphs>2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Uni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an Gosmain</dc:creator>
  <cp:lastModifiedBy>Rodolphe Dusaulcy</cp:lastModifiedBy>
  <cp:revision>181</cp:revision>
  <cp:lastPrinted>2018-10-26T15:14:21Z</cp:lastPrinted>
  <dcterms:created xsi:type="dcterms:W3CDTF">2018-03-28T11:59:25Z</dcterms:created>
  <dcterms:modified xsi:type="dcterms:W3CDTF">2019-01-21T16:00:23Z</dcterms:modified>
</cp:coreProperties>
</file>